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8"/>
  </p:notesMasterIdLst>
  <p:sldIdLst>
    <p:sldId id="258" r:id="rId2"/>
    <p:sldId id="259" r:id="rId3"/>
    <p:sldId id="265" r:id="rId4"/>
    <p:sldId id="261" r:id="rId5"/>
    <p:sldId id="266" r:id="rId6"/>
    <p:sldId id="262" r:id="rId7"/>
  </p:sldIdLst>
  <p:sldSz cx="9144000" cy="6858000" type="screen4x3"/>
  <p:notesSz cx="6881813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18"/>
    <p:restoredTop sz="94613"/>
  </p:normalViewPr>
  <p:slideViewPr>
    <p:cSldViewPr snapToGrid="0" snapToObjects="1">
      <p:cViewPr varScale="1">
        <p:scale>
          <a:sx n="80" d="100"/>
          <a:sy n="80" d="100"/>
        </p:scale>
        <p:origin x="150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98102" y="0"/>
            <a:ext cx="2982119" cy="466434"/>
          </a:xfrm>
          <a:prstGeom prst="rect">
            <a:avLst/>
          </a:prstGeom>
        </p:spPr>
        <p:txBody>
          <a:bodyPr vert="horz" lIns="92446" tIns="46223" rIns="92446" bIns="46223" rtlCol="0"/>
          <a:lstStyle>
            <a:lvl1pPr algn="r">
              <a:defRPr sz="1200"/>
            </a:lvl1pPr>
          </a:lstStyle>
          <a:p>
            <a:fld id="{4D391E3F-9483-7F4B-8C11-DE7B906DF48E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50963" y="1162050"/>
            <a:ext cx="4179887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46" tIns="46223" rIns="92446" bIns="46223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8182" y="4473892"/>
            <a:ext cx="5505450" cy="3660458"/>
          </a:xfrm>
          <a:prstGeom prst="rect">
            <a:avLst/>
          </a:prstGeom>
        </p:spPr>
        <p:txBody>
          <a:bodyPr vert="horz" lIns="92446" tIns="46223" rIns="92446" bIns="46223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98102" y="8829967"/>
            <a:ext cx="2982119" cy="466433"/>
          </a:xfrm>
          <a:prstGeom prst="rect">
            <a:avLst/>
          </a:prstGeom>
        </p:spPr>
        <p:txBody>
          <a:bodyPr vert="horz" lIns="92446" tIns="46223" rIns="92446" bIns="46223" rtlCol="0" anchor="b"/>
          <a:lstStyle>
            <a:lvl1pPr algn="r">
              <a:defRPr sz="1200"/>
            </a:lvl1pPr>
          </a:lstStyle>
          <a:p>
            <a:fld id="{64EFC5C1-EC5D-2540-AE51-755CF0578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3083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4197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19826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033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000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5379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0148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38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66507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29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668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7899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A55802-DD08-C04E-B86A-4A4748C4B915}" type="datetimeFigureOut">
              <a:rPr lang="en-US" smtClean="0"/>
              <a:t>10/1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2993D4-B57E-9948-B6AC-DEBDE90FD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97422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10" Type="http://schemas.openxmlformats.org/officeDocument/2006/relationships/image" Target="../media/image9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tiff"/><Relationship Id="rId3" Type="http://schemas.openxmlformats.org/officeDocument/2006/relationships/image" Target="../media/image11.tiff"/><Relationship Id="rId7" Type="http://schemas.openxmlformats.org/officeDocument/2006/relationships/image" Target="../media/image15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10" Type="http://schemas.openxmlformats.org/officeDocument/2006/relationships/image" Target="../media/image18.tiff"/><Relationship Id="rId4" Type="http://schemas.openxmlformats.org/officeDocument/2006/relationships/image" Target="../media/image12.tiff"/><Relationship Id="rId9" Type="http://schemas.openxmlformats.org/officeDocument/2006/relationships/image" Target="../media/image1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tiff"/><Relationship Id="rId5" Type="http://schemas.openxmlformats.org/officeDocument/2006/relationships/image" Target="../media/image22.tiff"/><Relationship Id="rId4" Type="http://schemas.openxmlformats.org/officeDocument/2006/relationships/image" Target="../media/image21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tiff"/><Relationship Id="rId2" Type="http://schemas.openxmlformats.org/officeDocument/2006/relationships/image" Target="../media/image25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7.tif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5"/>
          <p:cNvGrpSpPr/>
          <p:nvPr/>
        </p:nvGrpSpPr>
        <p:grpSpPr>
          <a:xfrm>
            <a:off x="3167184" y="2370707"/>
            <a:ext cx="2178657" cy="2119546"/>
            <a:chOff x="2267696" y="550798"/>
            <a:chExt cx="3116019" cy="2869532"/>
          </a:xfrm>
        </p:grpSpPr>
        <p:pic>
          <p:nvPicPr>
            <p:cNvPr id="15" name="Picture 1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267696" y="550798"/>
              <a:ext cx="3116019" cy="2869532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2712020" y="965767"/>
              <a:ext cx="542461" cy="3541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376606" y="2014902"/>
              <a:ext cx="486695" cy="3541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549570" y="2576049"/>
              <a:ext cx="491379" cy="3541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</p:grpSp>
      <p:sp>
        <p:nvSpPr>
          <p:cNvPr id="10" name="TextBox 9"/>
          <p:cNvSpPr txBox="1"/>
          <p:nvPr/>
        </p:nvSpPr>
        <p:spPr>
          <a:xfrm>
            <a:off x="6335114" y="2476810"/>
            <a:ext cx="206926" cy="29553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solidFill>
                  <a:schemeClr val="bg1"/>
                </a:solidFill>
              </a:rPr>
              <a:t>g</a:t>
            </a:r>
          </a:p>
        </p:txBody>
      </p:sp>
      <p:grpSp>
        <p:nvGrpSpPr>
          <p:cNvPr id="75" name="Group 74"/>
          <p:cNvGrpSpPr/>
          <p:nvPr/>
        </p:nvGrpSpPr>
        <p:grpSpPr>
          <a:xfrm>
            <a:off x="100376" y="2370667"/>
            <a:ext cx="2949446" cy="2119546"/>
            <a:chOff x="3357558" y="46702"/>
            <a:chExt cx="4028885" cy="2869532"/>
          </a:xfrm>
        </p:grpSpPr>
        <p:pic>
          <p:nvPicPr>
            <p:cNvPr id="24" name="Picture 2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57558" y="46702"/>
              <a:ext cx="4028885" cy="2869532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3677913" y="873877"/>
              <a:ext cx="520243" cy="3541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318827" y="1212935"/>
              <a:ext cx="471252" cy="3541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243981" y="317205"/>
              <a:ext cx="466760" cy="3541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</p:grpSp>
      <p:sp>
        <p:nvSpPr>
          <p:cNvPr id="60" name="TextBox 59"/>
          <p:cNvSpPr txBox="1"/>
          <p:nvPr/>
        </p:nvSpPr>
        <p:spPr>
          <a:xfrm>
            <a:off x="944039" y="4648207"/>
            <a:ext cx="2113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solidFill>
                  <a:schemeClr val="bg1"/>
                </a:solidFill>
              </a:rPr>
              <a:t>h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222790" y="4659266"/>
            <a:ext cx="2113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solidFill>
                  <a:schemeClr val="bg1"/>
                </a:solidFill>
              </a:rPr>
              <a:t>k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7427764" y="4648203"/>
            <a:ext cx="211300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sz="1350" dirty="0">
              <a:solidFill>
                <a:schemeClr val="bg1"/>
              </a:solidFill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13076" y="4626186"/>
            <a:ext cx="7519339" cy="2135982"/>
            <a:chOff x="122908" y="4626186"/>
            <a:chExt cx="7519339" cy="2135982"/>
          </a:xfrm>
        </p:grpSpPr>
        <p:grpSp>
          <p:nvGrpSpPr>
            <p:cNvPr id="58" name="Group 57"/>
            <p:cNvGrpSpPr/>
            <p:nvPr/>
          </p:nvGrpSpPr>
          <p:grpSpPr>
            <a:xfrm>
              <a:off x="122908" y="4626715"/>
              <a:ext cx="2151794" cy="2128188"/>
              <a:chOff x="5324853" y="295270"/>
              <a:chExt cx="2978835" cy="2743200"/>
            </a:xfrm>
          </p:grpSpPr>
          <p:pic>
            <p:nvPicPr>
              <p:cNvPr id="67" name="Picture 66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324853" y="295270"/>
                <a:ext cx="2978835" cy="2743200"/>
              </a:xfrm>
              <a:prstGeom prst="rect">
                <a:avLst/>
              </a:prstGeom>
            </p:spPr>
          </p:pic>
          <p:grpSp>
            <p:nvGrpSpPr>
              <p:cNvPr id="68" name="Group 67"/>
              <p:cNvGrpSpPr/>
              <p:nvPr/>
            </p:nvGrpSpPr>
            <p:grpSpPr>
              <a:xfrm>
                <a:off x="5484117" y="687728"/>
                <a:ext cx="2819571" cy="1680543"/>
                <a:chOff x="5484117" y="687728"/>
                <a:chExt cx="2819571" cy="1680543"/>
              </a:xfrm>
            </p:grpSpPr>
            <p:sp>
              <p:nvSpPr>
                <p:cNvPr id="69" name="TextBox 68"/>
                <p:cNvSpPr txBox="1"/>
                <p:nvPr/>
              </p:nvSpPr>
              <p:spPr>
                <a:xfrm>
                  <a:off x="6347357" y="1341259"/>
                  <a:ext cx="529425" cy="3372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solidFill>
                        <a:srgbClr val="FFFF00"/>
                      </a:solidFill>
                    </a:rPr>
                    <a:t>BL</a:t>
                  </a:r>
                </a:p>
              </p:txBody>
            </p:sp>
            <p:sp>
              <p:nvSpPr>
                <p:cNvPr id="70" name="TextBox 69"/>
                <p:cNvSpPr txBox="1"/>
                <p:nvPr/>
              </p:nvSpPr>
              <p:spPr>
                <a:xfrm>
                  <a:off x="5484117" y="687728"/>
                  <a:ext cx="542463" cy="3372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solidFill>
                        <a:srgbClr val="FFFF00"/>
                      </a:solidFill>
                    </a:rPr>
                    <a:t>Mu</a:t>
                  </a:r>
                </a:p>
              </p:txBody>
            </p:sp>
            <p:sp>
              <p:nvSpPr>
                <p:cNvPr id="71" name="TextBox 70"/>
                <p:cNvSpPr txBox="1"/>
                <p:nvPr/>
              </p:nvSpPr>
              <p:spPr>
                <a:xfrm>
                  <a:off x="6501758" y="840128"/>
                  <a:ext cx="542463" cy="3372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solidFill>
                        <a:srgbClr val="FFFF00"/>
                      </a:solidFill>
                    </a:rPr>
                    <a:t>TC</a:t>
                  </a:r>
                </a:p>
              </p:txBody>
            </p:sp>
            <p:sp>
              <p:nvSpPr>
                <p:cNvPr id="72" name="TextBox 71"/>
                <p:cNvSpPr txBox="1"/>
                <p:nvPr/>
              </p:nvSpPr>
              <p:spPr>
                <a:xfrm>
                  <a:off x="7558729" y="992527"/>
                  <a:ext cx="542463" cy="3372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solidFill>
                        <a:srgbClr val="FFFF00"/>
                      </a:solidFill>
                    </a:rPr>
                    <a:t>TC</a:t>
                  </a:r>
                </a:p>
              </p:txBody>
            </p:sp>
            <p:sp>
              <p:nvSpPr>
                <p:cNvPr id="73" name="TextBox 72"/>
                <p:cNvSpPr txBox="1"/>
                <p:nvPr/>
              </p:nvSpPr>
              <p:spPr>
                <a:xfrm>
                  <a:off x="7761225" y="2031060"/>
                  <a:ext cx="542463" cy="33721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solidFill>
                        <a:srgbClr val="FFFF00"/>
                      </a:solidFill>
                    </a:rPr>
                    <a:t>Mu</a:t>
                  </a:r>
                </a:p>
              </p:txBody>
            </p:sp>
          </p:grpSp>
        </p:grpSp>
        <p:grpSp>
          <p:nvGrpSpPr>
            <p:cNvPr id="59" name="Group 58"/>
            <p:cNvGrpSpPr/>
            <p:nvPr/>
          </p:nvGrpSpPr>
          <p:grpSpPr>
            <a:xfrm>
              <a:off x="5405823" y="4630306"/>
              <a:ext cx="2236424" cy="2131862"/>
              <a:chOff x="5755017" y="3678203"/>
              <a:chExt cx="2516295" cy="2271601"/>
            </a:xfrm>
          </p:grpSpPr>
          <p:pic>
            <p:nvPicPr>
              <p:cNvPr id="63" name="Picture 62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804589" y="3678203"/>
                <a:ext cx="2466723" cy="2271601"/>
              </a:xfrm>
              <a:prstGeom prst="rect">
                <a:avLst/>
              </a:prstGeom>
            </p:spPr>
          </p:pic>
          <p:sp>
            <p:nvSpPr>
              <p:cNvPr id="64" name="TextBox 63"/>
              <p:cNvSpPr txBox="1"/>
              <p:nvPr/>
            </p:nvSpPr>
            <p:spPr>
              <a:xfrm>
                <a:off x="7568134" y="4125315"/>
                <a:ext cx="412955" cy="278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solidFill>
                      <a:srgbClr val="FFFF00"/>
                    </a:solidFill>
                  </a:rPr>
                  <a:t>BL</a:t>
                </a:r>
              </a:p>
            </p:txBody>
          </p:sp>
          <p:sp>
            <p:nvSpPr>
              <p:cNvPr id="65" name="TextBox 64"/>
              <p:cNvSpPr txBox="1"/>
              <p:nvPr/>
            </p:nvSpPr>
            <p:spPr>
              <a:xfrm>
                <a:off x="7626323" y="5418906"/>
                <a:ext cx="542463" cy="278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solidFill>
                      <a:srgbClr val="FFFF00"/>
                    </a:solidFill>
                  </a:rPr>
                  <a:t>Mu</a:t>
                </a:r>
              </a:p>
            </p:txBody>
          </p:sp>
          <p:sp>
            <p:nvSpPr>
              <p:cNvPr id="66" name="TextBox 65"/>
              <p:cNvSpPr txBox="1"/>
              <p:nvPr/>
            </p:nvSpPr>
            <p:spPr>
              <a:xfrm>
                <a:off x="5755017" y="3998805"/>
                <a:ext cx="542462" cy="27875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solidFill>
                      <a:srgbClr val="FFFF00"/>
                    </a:solidFill>
                  </a:rPr>
                  <a:t>Mu</a:t>
                </a:r>
              </a:p>
            </p:txBody>
          </p:sp>
        </p:grpSp>
        <p:pic>
          <p:nvPicPr>
            <p:cNvPr id="57" name="Picture 5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92857" y="4626186"/>
              <a:ext cx="2949446" cy="2131193"/>
            </a:xfrm>
            <a:prstGeom prst="rect">
              <a:avLst/>
            </a:prstGeom>
          </p:spPr>
        </p:pic>
      </p:grpSp>
      <p:sp>
        <p:nvSpPr>
          <p:cNvPr id="54" name="TextBox 53"/>
          <p:cNvSpPr txBox="1"/>
          <p:nvPr/>
        </p:nvSpPr>
        <p:spPr>
          <a:xfrm>
            <a:off x="3701447" y="5444738"/>
            <a:ext cx="4821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FF00"/>
                </a:solidFill>
              </a:rPr>
              <a:t>Mu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4587044" y="5307393"/>
            <a:ext cx="3670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FF00"/>
                </a:solidFill>
              </a:rPr>
              <a:t>BL</a:t>
            </a:r>
          </a:p>
        </p:txBody>
      </p:sp>
      <p:pic>
        <p:nvPicPr>
          <p:cNvPr id="88" name="Picture 8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751" y="167308"/>
            <a:ext cx="2142516" cy="2080482"/>
          </a:xfrm>
          <a:prstGeom prst="rect">
            <a:avLst/>
          </a:prstGeom>
        </p:spPr>
      </p:pic>
      <p:cxnSp>
        <p:nvCxnSpPr>
          <p:cNvPr id="89" name="Straight Arrow Connector 88"/>
          <p:cNvCxnSpPr/>
          <p:nvPr/>
        </p:nvCxnSpPr>
        <p:spPr>
          <a:xfrm flipH="1" flipV="1">
            <a:off x="478698" y="521123"/>
            <a:ext cx="93260" cy="176595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/>
          <p:cNvCxnSpPr/>
          <p:nvPr/>
        </p:nvCxnSpPr>
        <p:spPr>
          <a:xfrm flipH="1">
            <a:off x="631617" y="1792894"/>
            <a:ext cx="232325" cy="8430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/>
          <p:cNvCxnSpPr/>
          <p:nvPr/>
        </p:nvCxnSpPr>
        <p:spPr>
          <a:xfrm>
            <a:off x="1789878" y="1890164"/>
            <a:ext cx="211094" cy="80957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1515068" y="532224"/>
            <a:ext cx="3766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FF00"/>
                </a:solidFill>
              </a:rPr>
              <a:t>TC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715758" y="876625"/>
            <a:ext cx="39603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FF00"/>
                </a:solidFill>
              </a:rPr>
              <a:t>Mu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1028655" y="1665426"/>
            <a:ext cx="38233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FF00"/>
                </a:solidFill>
              </a:rPr>
              <a:t>Mu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3378718" y="167308"/>
            <a:ext cx="14565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dirty="0">
                <a:solidFill>
                  <a:schemeClr val="bg1"/>
                </a:solidFill>
              </a:rPr>
              <a:t>c</a:t>
            </a:r>
          </a:p>
        </p:txBody>
      </p:sp>
      <p:pic>
        <p:nvPicPr>
          <p:cNvPr id="84" name="Picture 8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1695" y="169011"/>
            <a:ext cx="2094045" cy="2080896"/>
          </a:xfrm>
          <a:prstGeom prst="rect">
            <a:avLst/>
          </a:prstGeom>
        </p:spPr>
      </p:pic>
      <p:sp>
        <p:nvSpPr>
          <p:cNvPr id="85" name="TextBox 84"/>
          <p:cNvSpPr txBox="1"/>
          <p:nvPr/>
        </p:nvSpPr>
        <p:spPr>
          <a:xfrm>
            <a:off x="2787687" y="1232806"/>
            <a:ext cx="4015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FF00"/>
                </a:solidFill>
              </a:rPr>
              <a:t>TC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3634338" y="1106749"/>
            <a:ext cx="34320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solidFill>
                  <a:srgbClr val="FFFF00"/>
                </a:solidFill>
              </a:rPr>
              <a:t>TC</a:t>
            </a:r>
          </a:p>
        </p:txBody>
      </p:sp>
      <p:grpSp>
        <p:nvGrpSpPr>
          <p:cNvPr id="97" name="Group 96"/>
          <p:cNvGrpSpPr/>
          <p:nvPr/>
        </p:nvGrpSpPr>
        <p:grpSpPr>
          <a:xfrm>
            <a:off x="4523940" y="169240"/>
            <a:ext cx="2115109" cy="2085861"/>
            <a:chOff x="0" y="1479884"/>
            <a:chExt cx="2980944" cy="2745147"/>
          </a:xfrm>
        </p:grpSpPr>
        <p:pic>
          <p:nvPicPr>
            <p:cNvPr id="104" name="Picture 103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479884"/>
              <a:ext cx="2980944" cy="2745147"/>
            </a:xfrm>
            <a:prstGeom prst="rect">
              <a:avLst/>
            </a:prstGeom>
          </p:spPr>
        </p:pic>
        <p:sp>
          <p:nvSpPr>
            <p:cNvPr id="105" name="TextBox 104"/>
            <p:cNvSpPr txBox="1"/>
            <p:nvPr/>
          </p:nvSpPr>
          <p:spPr>
            <a:xfrm>
              <a:off x="1684550" y="3126658"/>
              <a:ext cx="557511" cy="344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686571" y="2384320"/>
              <a:ext cx="542462" cy="3442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</p:grpSp>
      <p:grpSp>
        <p:nvGrpSpPr>
          <p:cNvPr id="98" name="Group 97"/>
          <p:cNvGrpSpPr/>
          <p:nvPr/>
        </p:nvGrpSpPr>
        <p:grpSpPr>
          <a:xfrm>
            <a:off x="6728541" y="169241"/>
            <a:ext cx="2142620" cy="2085861"/>
            <a:chOff x="6153998" y="1479883"/>
            <a:chExt cx="2998617" cy="2761417"/>
          </a:xfrm>
        </p:grpSpPr>
        <p:pic>
          <p:nvPicPr>
            <p:cNvPr id="99" name="Picture 98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53998" y="1479883"/>
              <a:ext cx="2998617" cy="2761417"/>
            </a:xfrm>
            <a:prstGeom prst="rect">
              <a:avLst/>
            </a:prstGeom>
          </p:spPr>
        </p:pic>
        <p:sp>
          <p:nvSpPr>
            <p:cNvPr id="100" name="TextBox 99"/>
            <p:cNvSpPr txBox="1"/>
            <p:nvPr/>
          </p:nvSpPr>
          <p:spPr>
            <a:xfrm>
              <a:off x="6684258" y="3082413"/>
              <a:ext cx="486696" cy="3463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101" name="TextBox 100"/>
            <p:cNvSpPr txBox="1"/>
            <p:nvPr/>
          </p:nvSpPr>
          <p:spPr>
            <a:xfrm>
              <a:off x="8439326" y="1651815"/>
              <a:ext cx="482566" cy="3463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8551750" y="2798085"/>
              <a:ext cx="542461" cy="3463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7141456" y="1927117"/>
              <a:ext cx="542461" cy="34633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</p:grpSp>
      <p:sp>
        <p:nvSpPr>
          <p:cNvPr id="28" name="TextBox 27"/>
          <p:cNvSpPr txBox="1"/>
          <p:nvPr/>
        </p:nvSpPr>
        <p:spPr>
          <a:xfrm>
            <a:off x="62334" y="109742"/>
            <a:ext cx="721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solidFill>
                  <a:schemeClr val="bg1"/>
                </a:solidFill>
              </a:rPr>
              <a:t>sugarfed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07" name="TextBox 106"/>
          <p:cNvSpPr txBox="1"/>
          <p:nvPr/>
        </p:nvSpPr>
        <p:spPr>
          <a:xfrm>
            <a:off x="2299179" y="114657"/>
            <a:ext cx="721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solidFill>
                  <a:schemeClr val="bg1"/>
                </a:solidFill>
              </a:rPr>
              <a:t>sugarfed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4477030" y="119571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8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6684377" y="124490"/>
            <a:ext cx="7328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8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42664" y="2322000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24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3125087" y="2317084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24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52501" y="4583426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32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2318839" y="4578506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32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5381594" y="4573590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32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653820" y="1373837"/>
            <a:ext cx="37663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solidFill>
                  <a:srgbClr val="FFFF00"/>
                </a:solidFill>
              </a:rPr>
              <a:t>BL</a:t>
            </a:r>
            <a:endParaRPr lang="en-US" sz="1100" dirty="0">
              <a:solidFill>
                <a:srgbClr val="FFFF00"/>
              </a:solidFill>
            </a:endParaRPr>
          </a:p>
        </p:txBody>
      </p:sp>
      <p:sp>
        <p:nvSpPr>
          <p:cNvPr id="118" name="Rectangle 117"/>
          <p:cNvSpPr/>
          <p:nvPr/>
        </p:nvSpPr>
        <p:spPr>
          <a:xfrm>
            <a:off x="5472006" y="2318391"/>
            <a:ext cx="3407958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S1: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Ultrastructural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SEM) imaging of the midgut surface of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garfed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sz="12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oodfed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CHIKV-infected) </a:t>
            </a:r>
            <a:r>
              <a:rPr lang="en-US" sz="12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e</a:t>
            </a:r>
            <a:r>
              <a:rPr lang="en-US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egypti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t 8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24, 32, 48, 72, and 96 h post-infectious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oodmeal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ibm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These are additional (replicate) images from the same experiment presented in Figure 2. Images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were generated using a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EI Quanta 600F scanning electron microscope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Magnifications ranged from 625x to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0,000x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s indicated on each panel. BL = basal lamina; Mu = muscle tissue; TC = tracheal cell.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ed arrows indicate slight tears in the midgut BL of the </a:t>
            </a:r>
            <a:r>
              <a:rPr lang="en-US" sz="12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garfed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ntrol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7751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4885550" y="99570"/>
            <a:ext cx="2234123" cy="2057400"/>
            <a:chOff x="108662" y="1378788"/>
            <a:chExt cx="2978830" cy="2743200"/>
          </a:xfrm>
        </p:grpSpPr>
        <p:pic>
          <p:nvPicPr>
            <p:cNvPr id="19" name="Picture 18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8662" y="1378788"/>
              <a:ext cx="2978830" cy="2743200"/>
            </a:xfrm>
            <a:prstGeom prst="rect">
              <a:avLst/>
            </a:prstGeom>
          </p:spPr>
        </p:pic>
        <p:sp>
          <p:nvSpPr>
            <p:cNvPr id="20" name="TextBox 19"/>
            <p:cNvSpPr txBox="1"/>
            <p:nvPr/>
          </p:nvSpPr>
          <p:spPr>
            <a:xfrm>
              <a:off x="2398647" y="2381196"/>
              <a:ext cx="54246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436696" y="3218887"/>
              <a:ext cx="54246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493582" y="99570"/>
            <a:ext cx="2234123" cy="2057400"/>
            <a:chOff x="3246549" y="1380174"/>
            <a:chExt cx="2978830" cy="2743200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6549" y="1380174"/>
              <a:ext cx="2978830" cy="274320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4978845" y="2283353"/>
              <a:ext cx="54246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144295" y="3130810"/>
              <a:ext cx="54246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499090" y="2196530"/>
              <a:ext cx="54246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471717" y="3403553"/>
              <a:ext cx="54246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165616" y="99570"/>
            <a:ext cx="2175235" cy="2057400"/>
            <a:chOff x="6440526" y="1390006"/>
            <a:chExt cx="2978830" cy="2743200"/>
          </a:xfrm>
        </p:grpSpPr>
        <p:pic>
          <p:nvPicPr>
            <p:cNvPr id="11" name="Picture 10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40526" y="1390006"/>
              <a:ext cx="2978830" cy="2743200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7352290" y="2394279"/>
              <a:ext cx="54246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450547" y="2975762"/>
              <a:ext cx="54246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139041" y="60674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48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grpSp>
        <p:nvGrpSpPr>
          <p:cNvPr id="24" name="Group 23"/>
          <p:cNvGrpSpPr/>
          <p:nvPr/>
        </p:nvGrpSpPr>
        <p:grpSpPr>
          <a:xfrm>
            <a:off x="188494" y="2242275"/>
            <a:ext cx="2167549" cy="2057400"/>
            <a:chOff x="4701595" y="3418917"/>
            <a:chExt cx="2978830" cy="2743200"/>
          </a:xfrm>
        </p:grpSpPr>
        <p:pic>
          <p:nvPicPr>
            <p:cNvPr id="36" name="Picture 35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01595" y="3418917"/>
              <a:ext cx="2978830" cy="2743200"/>
            </a:xfrm>
            <a:prstGeom prst="rect">
              <a:avLst/>
            </a:prstGeom>
          </p:spPr>
        </p:pic>
        <p:sp>
          <p:nvSpPr>
            <p:cNvPr id="37" name="TextBox 36"/>
            <p:cNvSpPr txBox="1"/>
            <p:nvPr/>
          </p:nvSpPr>
          <p:spPr>
            <a:xfrm>
              <a:off x="5698137" y="5519542"/>
              <a:ext cx="492872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339653" y="4273108"/>
              <a:ext cx="492872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5156237" y="4186848"/>
              <a:ext cx="54190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737244" y="5350701"/>
              <a:ext cx="54190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4907001" y="2247109"/>
            <a:ext cx="2232943" cy="2057400"/>
            <a:chOff x="5775420" y="368095"/>
            <a:chExt cx="2977257" cy="2743200"/>
          </a:xfrm>
        </p:grpSpPr>
        <p:pic>
          <p:nvPicPr>
            <p:cNvPr id="31" name="Picture 30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75420" y="368095"/>
              <a:ext cx="2977252" cy="2743200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7111309" y="1725974"/>
              <a:ext cx="575975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6046583" y="1672980"/>
              <a:ext cx="471477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8259805" y="2350218"/>
              <a:ext cx="492872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8126762" y="524186"/>
              <a:ext cx="54190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</p:grpSp>
      <p:grpSp>
        <p:nvGrpSpPr>
          <p:cNvPr id="26" name="Group 25"/>
          <p:cNvGrpSpPr/>
          <p:nvPr/>
        </p:nvGrpSpPr>
        <p:grpSpPr>
          <a:xfrm>
            <a:off x="2510408" y="2244835"/>
            <a:ext cx="2234123" cy="2057400"/>
            <a:chOff x="2612473" y="282370"/>
            <a:chExt cx="2978830" cy="2743200"/>
          </a:xfrm>
        </p:grpSpPr>
        <p:pic>
          <p:nvPicPr>
            <p:cNvPr id="27" name="Picture 26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612473" y="282370"/>
              <a:ext cx="2978830" cy="2743200"/>
            </a:xfrm>
            <a:prstGeom prst="rect">
              <a:avLst/>
            </a:prstGeom>
          </p:spPr>
        </p:pic>
        <p:sp>
          <p:nvSpPr>
            <p:cNvPr id="28" name="TextBox 27"/>
            <p:cNvSpPr txBox="1"/>
            <p:nvPr/>
          </p:nvSpPr>
          <p:spPr>
            <a:xfrm>
              <a:off x="2695582" y="1154397"/>
              <a:ext cx="492872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3195886" y="1672981"/>
              <a:ext cx="54190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4669379" y="1425905"/>
              <a:ext cx="541901" cy="34881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2517751" y="4421169"/>
            <a:ext cx="2247518" cy="2064438"/>
            <a:chOff x="0" y="426868"/>
            <a:chExt cx="2978830" cy="2743200"/>
          </a:xfrm>
        </p:grpSpPr>
        <p:pic>
          <p:nvPicPr>
            <p:cNvPr id="80" name="Picture 79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426868"/>
              <a:ext cx="2978830" cy="2743200"/>
            </a:xfrm>
            <a:prstGeom prst="rect">
              <a:avLst/>
            </a:prstGeom>
          </p:spPr>
        </p:pic>
        <p:sp>
          <p:nvSpPr>
            <p:cNvPr id="81" name="TextBox 80"/>
            <p:cNvSpPr txBox="1"/>
            <p:nvPr/>
          </p:nvSpPr>
          <p:spPr>
            <a:xfrm>
              <a:off x="2354570" y="2123497"/>
              <a:ext cx="471477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1925895" y="1281799"/>
              <a:ext cx="541901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1085236" y="716445"/>
              <a:ext cx="541901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00549" y="1162504"/>
              <a:ext cx="541901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</p:grpSp>
      <p:grpSp>
        <p:nvGrpSpPr>
          <p:cNvPr id="70" name="Group 69"/>
          <p:cNvGrpSpPr/>
          <p:nvPr/>
        </p:nvGrpSpPr>
        <p:grpSpPr>
          <a:xfrm>
            <a:off x="191395" y="4421169"/>
            <a:ext cx="2181276" cy="2064438"/>
            <a:chOff x="3134772" y="426868"/>
            <a:chExt cx="2978830" cy="2743200"/>
          </a:xfrm>
        </p:grpSpPr>
        <p:pic>
          <p:nvPicPr>
            <p:cNvPr id="76" name="Picture 75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34772" y="426868"/>
              <a:ext cx="2978830" cy="2743200"/>
            </a:xfrm>
            <a:prstGeom prst="rect">
              <a:avLst/>
            </a:prstGeom>
          </p:spPr>
        </p:pic>
        <p:sp>
          <p:nvSpPr>
            <p:cNvPr id="77" name="TextBox 76"/>
            <p:cNvSpPr txBox="1"/>
            <p:nvPr/>
          </p:nvSpPr>
          <p:spPr>
            <a:xfrm>
              <a:off x="3746734" y="1958497"/>
              <a:ext cx="575974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4848756" y="1531836"/>
              <a:ext cx="598314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5453441" y="1113964"/>
              <a:ext cx="504907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4907001" y="4422664"/>
            <a:ext cx="2313435" cy="2064438"/>
            <a:chOff x="6269544" y="426868"/>
            <a:chExt cx="3066195" cy="2743200"/>
          </a:xfrm>
        </p:grpSpPr>
        <p:pic>
          <p:nvPicPr>
            <p:cNvPr id="72" name="Picture 7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69544" y="426868"/>
              <a:ext cx="2978830" cy="2743200"/>
            </a:xfrm>
            <a:prstGeom prst="rect">
              <a:avLst/>
            </a:prstGeom>
          </p:spPr>
        </p:pic>
        <p:sp>
          <p:nvSpPr>
            <p:cNvPr id="73" name="TextBox 72"/>
            <p:cNvSpPr txBox="1"/>
            <p:nvPr/>
          </p:nvSpPr>
          <p:spPr>
            <a:xfrm>
              <a:off x="7631290" y="1266366"/>
              <a:ext cx="504907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BL</a:t>
              </a: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7291274" y="2553344"/>
              <a:ext cx="575974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TC</a:t>
              </a:r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8737425" y="2195514"/>
              <a:ext cx="598314" cy="34762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dirty="0">
                  <a:solidFill>
                    <a:srgbClr val="FFFF00"/>
                  </a:solidFill>
                </a:rPr>
                <a:t>Mu</a:t>
              </a:r>
            </a:p>
          </p:txBody>
        </p:sp>
      </p:grpSp>
      <p:sp>
        <p:nvSpPr>
          <p:cNvPr id="90" name="TextBox 89"/>
          <p:cNvSpPr txBox="1"/>
          <p:nvPr/>
        </p:nvSpPr>
        <p:spPr>
          <a:xfrm>
            <a:off x="2454737" y="53334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48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822907" y="46218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48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21135" y="2193114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72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456304" y="2178362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72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850462" y="2193106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72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136473" y="4375814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96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2461803" y="4380732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96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865793" y="4375820"/>
            <a:ext cx="9864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solidFill>
                  <a:schemeClr val="bg1"/>
                </a:solidFill>
              </a:rPr>
              <a:t>96 h </a:t>
            </a:r>
            <a:r>
              <a:rPr lang="en-US" sz="1200" dirty="0" err="1" smtClean="0">
                <a:solidFill>
                  <a:schemeClr val="bg1"/>
                </a:solidFill>
              </a:rPr>
              <a:t>pibm</a:t>
            </a:r>
            <a:endParaRPr lang="en-US" sz="1200" dirty="0">
              <a:solidFill>
                <a:schemeClr val="bg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7277518" y="199173"/>
            <a:ext cx="1532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Figure S1 </a:t>
            </a:r>
            <a:r>
              <a:rPr lang="en-US" sz="1200" dirty="0" smtClean="0"/>
              <a:t>(continued)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217961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371861" y="171731"/>
            <a:ext cx="11273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24 h </a:t>
            </a:r>
            <a:r>
              <a:rPr lang="en-US" sz="1600" dirty="0" err="1" smtClean="0"/>
              <a:t>pibm</a:t>
            </a:r>
            <a:r>
              <a:rPr lang="en-US" sz="1600" dirty="0" smtClean="0"/>
              <a:t> 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3976264" y="179777"/>
            <a:ext cx="11273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32 h </a:t>
            </a:r>
            <a:r>
              <a:rPr lang="en-US" sz="1600" dirty="0" err="1" smtClean="0"/>
              <a:t>pibm</a:t>
            </a:r>
            <a:endParaRPr lang="en-US" sz="1600" dirty="0"/>
          </a:p>
        </p:txBody>
      </p:sp>
      <p:grpSp>
        <p:nvGrpSpPr>
          <p:cNvPr id="36" name="Group 35"/>
          <p:cNvGrpSpPr/>
          <p:nvPr/>
        </p:nvGrpSpPr>
        <p:grpSpPr>
          <a:xfrm>
            <a:off x="674677" y="518331"/>
            <a:ext cx="7807399" cy="5136407"/>
            <a:chOff x="32106" y="557811"/>
            <a:chExt cx="9063766" cy="5999247"/>
          </a:xfrm>
        </p:grpSpPr>
        <p:grpSp>
          <p:nvGrpSpPr>
            <p:cNvPr id="7" name="Group 6"/>
            <p:cNvGrpSpPr/>
            <p:nvPr/>
          </p:nvGrpSpPr>
          <p:grpSpPr>
            <a:xfrm>
              <a:off x="45245" y="557811"/>
              <a:ext cx="2953512" cy="2953512"/>
              <a:chOff x="1466338" y="733492"/>
              <a:chExt cx="2953512" cy="2953512"/>
            </a:xfrm>
          </p:grpSpPr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66338" y="733492"/>
                <a:ext cx="2953512" cy="2953512"/>
              </a:xfrm>
              <a:prstGeom prst="rect">
                <a:avLst/>
              </a:prstGeom>
            </p:spPr>
          </p:pic>
          <p:sp>
            <p:nvSpPr>
              <p:cNvPr id="34" name="TextBox 33"/>
              <p:cNvSpPr txBox="1"/>
              <p:nvPr/>
            </p:nvSpPr>
            <p:spPr>
              <a:xfrm>
                <a:off x="1874627" y="1275474"/>
                <a:ext cx="616840" cy="32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Blab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1697586" y="2801490"/>
                <a:ext cx="4301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rgbClr val="FFFF00"/>
                    </a:solidFill>
                  </a:rPr>
                  <a:t>BL</a:t>
                </a:r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32106" y="3603546"/>
              <a:ext cx="2953512" cy="2953512"/>
              <a:chOff x="4508326" y="733492"/>
              <a:chExt cx="2953512" cy="2953512"/>
            </a:xfrm>
          </p:grpSpPr>
          <p:pic>
            <p:nvPicPr>
              <p:cNvPr id="30" name="Picture 29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08326" y="733492"/>
                <a:ext cx="2953512" cy="2953512"/>
              </a:xfrm>
              <a:prstGeom prst="rect">
                <a:avLst/>
              </a:prstGeom>
            </p:spPr>
          </p:pic>
          <p:sp>
            <p:nvSpPr>
              <p:cNvPr id="31" name="TextBox 30"/>
              <p:cNvSpPr txBox="1"/>
              <p:nvPr/>
            </p:nvSpPr>
            <p:spPr>
              <a:xfrm>
                <a:off x="6462870" y="857799"/>
                <a:ext cx="5306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Mu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6728217" y="2071749"/>
                <a:ext cx="4301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rgbClr val="FFFF00"/>
                    </a:solidFill>
                  </a:rPr>
                  <a:t>BL</a:t>
                </a:r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3087233" y="557811"/>
              <a:ext cx="2953512" cy="2953512"/>
              <a:chOff x="1466338" y="3779227"/>
              <a:chExt cx="2953512" cy="2953512"/>
            </a:xfrm>
          </p:grpSpPr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66338" y="3779227"/>
                <a:ext cx="2953512" cy="2953512"/>
              </a:xfrm>
              <a:prstGeom prst="rect">
                <a:avLst/>
              </a:prstGeom>
            </p:spPr>
          </p:pic>
          <p:sp>
            <p:nvSpPr>
              <p:cNvPr id="27" name="TextBox 26"/>
              <p:cNvSpPr txBox="1"/>
              <p:nvPr/>
            </p:nvSpPr>
            <p:spPr>
              <a:xfrm>
                <a:off x="3889156" y="5205470"/>
                <a:ext cx="5306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Mu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125993" y="5927316"/>
                <a:ext cx="573655" cy="32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Blab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3724327" y="5900355"/>
                <a:ext cx="4301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rgbClr val="FFFF00"/>
                    </a:solidFill>
                  </a:rPr>
                  <a:t>BL</a:t>
                </a:r>
              </a:p>
            </p:txBody>
          </p:sp>
        </p:grpSp>
        <p:grpSp>
          <p:nvGrpSpPr>
            <p:cNvPr id="10" name="Group 9"/>
            <p:cNvGrpSpPr/>
            <p:nvPr/>
          </p:nvGrpSpPr>
          <p:grpSpPr>
            <a:xfrm>
              <a:off x="3087233" y="3603546"/>
              <a:ext cx="2953512" cy="2953512"/>
              <a:chOff x="4508326" y="3779227"/>
              <a:chExt cx="2953512" cy="2953512"/>
            </a:xfrm>
          </p:grpSpPr>
          <p:pic>
            <p:nvPicPr>
              <p:cNvPr id="22" name="Picture 21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08326" y="3779227"/>
                <a:ext cx="2953512" cy="2953512"/>
              </a:xfrm>
              <a:prstGeom prst="rect">
                <a:avLst/>
              </a:prstGeom>
            </p:spPr>
          </p:pic>
          <p:sp>
            <p:nvSpPr>
              <p:cNvPr id="23" name="TextBox 22"/>
              <p:cNvSpPr txBox="1"/>
              <p:nvPr/>
            </p:nvSpPr>
            <p:spPr>
              <a:xfrm>
                <a:off x="4805643" y="4080215"/>
                <a:ext cx="53069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Mu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5070990" y="5237691"/>
                <a:ext cx="4301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rgbClr val="FFFF00"/>
                    </a:solidFill>
                  </a:rPr>
                  <a:t>BL</a:t>
                </a:r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5084972" y="6114115"/>
                <a:ext cx="656663" cy="32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Blab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</p:grpSp>
        <p:grpSp>
          <p:nvGrpSpPr>
            <p:cNvPr id="11" name="Group 10"/>
            <p:cNvGrpSpPr/>
            <p:nvPr/>
          </p:nvGrpSpPr>
          <p:grpSpPr>
            <a:xfrm>
              <a:off x="6129221" y="557811"/>
              <a:ext cx="2953512" cy="2953512"/>
              <a:chOff x="1463040" y="198877"/>
              <a:chExt cx="2953512" cy="2953512"/>
            </a:xfrm>
          </p:grpSpPr>
          <p:pic>
            <p:nvPicPr>
              <p:cNvPr id="19" name="Picture 18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63040" y="198877"/>
                <a:ext cx="2953512" cy="2953512"/>
              </a:xfrm>
              <a:prstGeom prst="rect">
                <a:avLst/>
              </a:prstGeom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2322958" y="2380749"/>
                <a:ext cx="4301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rgbClr val="FFFF00"/>
                    </a:solidFill>
                  </a:rPr>
                  <a:t>BL</a:t>
                </a: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3777811" y="2380748"/>
                <a:ext cx="638739" cy="32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Blab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</p:grpSp>
        <p:grpSp>
          <p:nvGrpSpPr>
            <p:cNvPr id="12" name="Group 11"/>
            <p:cNvGrpSpPr/>
            <p:nvPr/>
          </p:nvGrpSpPr>
          <p:grpSpPr>
            <a:xfrm>
              <a:off x="6142360" y="3603546"/>
              <a:ext cx="2953512" cy="2953512"/>
              <a:chOff x="4507992" y="198877"/>
              <a:chExt cx="2953512" cy="2953512"/>
            </a:xfrm>
          </p:grpSpPr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07992" y="198877"/>
                <a:ext cx="2953512" cy="2953512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6318761" y="2519248"/>
                <a:ext cx="43017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solidFill>
                      <a:srgbClr val="FFFF00"/>
                    </a:solidFill>
                  </a:rPr>
                  <a:t>BL</a:t>
                </a: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025105" y="2135193"/>
                <a:ext cx="629920" cy="32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Blab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5276469" y="1053325"/>
                <a:ext cx="508477" cy="32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err="1" smtClean="0">
                    <a:solidFill>
                      <a:srgbClr val="FFFF00"/>
                    </a:solidFill>
                  </a:rPr>
                  <a:t>Mi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5124761" y="2541476"/>
                <a:ext cx="530264" cy="3235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FF00"/>
                    </a:solidFill>
                  </a:rPr>
                  <a:t>ER</a:t>
                </a:r>
                <a:endParaRPr lang="en-US" sz="1200" dirty="0">
                  <a:solidFill>
                    <a:srgbClr val="FFFF00"/>
                  </a:solidFill>
                </a:endParaRPr>
              </a:p>
            </p:txBody>
          </p:sp>
        </p:grpSp>
      </p:grpSp>
      <p:sp>
        <p:nvSpPr>
          <p:cNvPr id="13" name="TextBox 12"/>
          <p:cNvSpPr txBox="1"/>
          <p:nvPr/>
        </p:nvSpPr>
        <p:spPr>
          <a:xfrm>
            <a:off x="6667366" y="181091"/>
            <a:ext cx="11273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smtClean="0"/>
              <a:t>48 h </a:t>
            </a:r>
            <a:r>
              <a:rPr lang="en-US" sz="1600" dirty="0" err="1" smtClean="0"/>
              <a:t>pibm</a:t>
            </a:r>
            <a:endParaRPr lang="en-US" sz="1600" dirty="0"/>
          </a:p>
        </p:txBody>
      </p:sp>
      <p:sp>
        <p:nvSpPr>
          <p:cNvPr id="37" name="Rectangle 36"/>
          <p:cNvSpPr/>
          <p:nvPr/>
        </p:nvSpPr>
        <p:spPr>
          <a:xfrm>
            <a:off x="577887" y="5743982"/>
            <a:ext cx="8171258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2: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Higher magnification of ultrastructural (TEM) images showing midgut </a:t>
            </a:r>
            <a:r>
              <a:rPr lang="en-US" sz="1200" dirty="0" smtClean="0"/>
              <a:t>cross-sections obtained from </a:t>
            </a:r>
            <a:r>
              <a:rPr lang="en-US" sz="1200" dirty="0"/>
              <a:t>female </a:t>
            </a:r>
            <a:r>
              <a:rPr lang="en-US" sz="1200" i="1" dirty="0"/>
              <a:t>Ae. </a:t>
            </a:r>
            <a:r>
              <a:rPr lang="en-US" sz="1200" i="1" dirty="0" err="1"/>
              <a:t>aegypti</a:t>
            </a:r>
            <a:r>
              <a:rPr lang="en-US" sz="1200" dirty="0"/>
              <a:t>, which had been </a:t>
            </a:r>
            <a:r>
              <a:rPr lang="en-US" sz="1200" dirty="0" smtClean="0"/>
              <a:t>orally </a:t>
            </a:r>
            <a:r>
              <a:rPr lang="en-US" sz="1200" dirty="0"/>
              <a:t>infected with CHIKV (titer in the </a:t>
            </a:r>
            <a:r>
              <a:rPr lang="en-US" sz="1200" dirty="0" err="1"/>
              <a:t>bloodmeal</a:t>
            </a:r>
            <a:r>
              <a:rPr lang="en-US" sz="1200" dirty="0"/>
              <a:t>: 10</a:t>
            </a:r>
            <a:r>
              <a:rPr lang="en-US" sz="1200" baseline="30000" dirty="0"/>
              <a:t>7</a:t>
            </a:r>
            <a:r>
              <a:rPr lang="en-US" sz="1200" dirty="0"/>
              <a:t> </a:t>
            </a:r>
            <a:r>
              <a:rPr lang="en-US" sz="1200" dirty="0" err="1"/>
              <a:t>pfu</a:t>
            </a:r>
            <a:r>
              <a:rPr lang="en-US" sz="1200" dirty="0"/>
              <a:t>/ml</a:t>
            </a:r>
            <a:r>
              <a:rPr lang="en-US" sz="1200" dirty="0" smtClean="0"/>
              <a:t>) at 24, 32, and 48 h </a:t>
            </a:r>
            <a:r>
              <a:rPr lang="en-US" sz="1200" dirty="0" err="1" smtClean="0"/>
              <a:t>pibm</a:t>
            </a:r>
            <a:r>
              <a:rPr lang="en-US" sz="1200" dirty="0" smtClean="0"/>
              <a:t>. </a:t>
            </a:r>
            <a:r>
              <a:rPr lang="en-US" sz="1200" dirty="0"/>
              <a:t>Magnifications ranged from </a:t>
            </a:r>
            <a:r>
              <a:rPr lang="en-US" sz="1200" dirty="0" smtClean="0"/>
              <a:t>10,000x</a:t>
            </a:r>
            <a:r>
              <a:rPr lang="en-US" sz="1200" b="1" dirty="0" smtClean="0"/>
              <a:t> </a:t>
            </a:r>
            <a:r>
              <a:rPr lang="en-US" sz="1200" dirty="0"/>
              <a:t>to 25,000x. BL = basal lamina; Blab = basal labyrinth; ER = </a:t>
            </a:r>
            <a:r>
              <a:rPr lang="en-US" sz="1200" dirty="0" smtClean="0"/>
              <a:t>endoplasmic </a:t>
            </a:r>
            <a:r>
              <a:rPr lang="en-US" sz="1200" dirty="0"/>
              <a:t>reticulum; </a:t>
            </a:r>
            <a:r>
              <a:rPr lang="en-US" sz="1200" dirty="0" smtClean="0"/>
              <a:t>Mu </a:t>
            </a:r>
            <a:r>
              <a:rPr lang="en-US" sz="1200" dirty="0"/>
              <a:t>= muscle; </a:t>
            </a:r>
            <a:r>
              <a:rPr lang="en-US" sz="1200" dirty="0" err="1"/>
              <a:t>Mi</a:t>
            </a:r>
            <a:r>
              <a:rPr lang="en-US" sz="1200" dirty="0"/>
              <a:t> = </a:t>
            </a:r>
            <a:r>
              <a:rPr lang="en-US" sz="1200" dirty="0" smtClean="0"/>
              <a:t>mitochondrion.</a:t>
            </a:r>
            <a:endParaRPr lang="en-US" sz="12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040184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364249" y="410332"/>
            <a:ext cx="8428248" cy="2729362"/>
            <a:chOff x="632180" y="410332"/>
            <a:chExt cx="8428248" cy="2729362"/>
          </a:xfrm>
        </p:grpSpPr>
        <p:pic>
          <p:nvPicPr>
            <p:cNvPr id="8" name="Picture 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88221" y="454516"/>
              <a:ext cx="2672207" cy="2672207"/>
            </a:xfrm>
            <a:prstGeom prst="rect">
              <a:avLst/>
            </a:prstGeom>
          </p:spPr>
        </p:pic>
        <p:grpSp>
          <p:nvGrpSpPr>
            <p:cNvPr id="17" name="Group 16"/>
            <p:cNvGrpSpPr/>
            <p:nvPr/>
          </p:nvGrpSpPr>
          <p:grpSpPr>
            <a:xfrm>
              <a:off x="3465874" y="454517"/>
              <a:ext cx="2787442" cy="2685177"/>
              <a:chOff x="4557594" y="429422"/>
              <a:chExt cx="3098800" cy="3098800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557594" y="429422"/>
                <a:ext cx="3098800" cy="3098800"/>
              </a:xfrm>
              <a:prstGeom prst="rect">
                <a:avLst/>
              </a:prstGeom>
            </p:spPr>
          </p:pic>
          <p:cxnSp>
            <p:nvCxnSpPr>
              <p:cNvPr id="3" name="Straight Arrow Connector 2"/>
              <p:cNvCxnSpPr/>
              <p:nvPr/>
            </p:nvCxnSpPr>
            <p:spPr>
              <a:xfrm>
                <a:off x="5818146" y="1708442"/>
                <a:ext cx="161925" cy="180975"/>
              </a:xfrm>
              <a:prstGeom prst="straightConnector1">
                <a:avLst/>
              </a:prstGeom>
              <a:ln>
                <a:solidFill>
                  <a:srgbClr val="FFC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Arrow Connector 11"/>
              <p:cNvCxnSpPr/>
              <p:nvPr/>
            </p:nvCxnSpPr>
            <p:spPr>
              <a:xfrm>
                <a:off x="5647210" y="1771035"/>
                <a:ext cx="161925" cy="180975"/>
              </a:xfrm>
              <a:prstGeom prst="straightConnector1">
                <a:avLst/>
              </a:prstGeom>
              <a:ln>
                <a:solidFill>
                  <a:srgbClr val="FFC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Arrow Connector 12"/>
              <p:cNvCxnSpPr/>
              <p:nvPr/>
            </p:nvCxnSpPr>
            <p:spPr>
              <a:xfrm>
                <a:off x="5612554" y="1918671"/>
                <a:ext cx="179506" cy="147638"/>
              </a:xfrm>
              <a:prstGeom prst="straightConnector1">
                <a:avLst/>
              </a:prstGeom>
              <a:ln>
                <a:solidFill>
                  <a:srgbClr val="FFC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8761" y="454517"/>
              <a:ext cx="2672207" cy="2672207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632180" y="414761"/>
              <a:ext cx="1670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3438606" y="429727"/>
              <a:ext cx="1670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b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348466" y="410332"/>
              <a:ext cx="16704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solidFill>
                    <a:schemeClr val="bg1"/>
                  </a:solidFill>
                </a:rPr>
                <a:t>c</a:t>
              </a:r>
            </a:p>
          </p:txBody>
        </p:sp>
      </p:grpSp>
      <p:sp>
        <p:nvSpPr>
          <p:cNvPr id="4" name="Rectangle 3"/>
          <p:cNvSpPr/>
          <p:nvPr/>
        </p:nvSpPr>
        <p:spPr>
          <a:xfrm>
            <a:off x="276660" y="3244094"/>
            <a:ext cx="851583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3: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are events observed during the ultrastructural TEM time course study. (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, b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: Infection of tracheal tissue with CHIKV at 40 h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st-infectious </a:t>
            </a:r>
            <a:r>
              <a:rPr lang="en-US" sz="12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oodmeal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en-US" sz="12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ibm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nearby region of the midgut epithelium does not appear to be virus infected. (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Higher magnification of the tracheal cell cross section of (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showing the presence of </a:t>
            </a:r>
            <a:r>
              <a:rPr 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virion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orange arrows). (</a:t>
            </a:r>
            <a:r>
              <a:rPr 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A degenerating cell with a vesicular appearing nucleus and a reduced </a:t>
            </a:r>
            <a:r>
              <a:rPr 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ytoplasmic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ensity. The structure of the ER is no longer visible. </a:t>
            </a:r>
          </a:p>
        </p:txBody>
      </p:sp>
    </p:spTree>
    <p:extLst>
      <p:ext uri="{BB962C8B-B14F-4D97-AF65-F5344CB8AC3E}">
        <p14:creationId xmlns:p14="http://schemas.microsoft.com/office/powerpoint/2010/main" val="12721858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10380404"/>
              </p:ext>
            </p:extLst>
          </p:nvPr>
        </p:nvGraphicFramePr>
        <p:xfrm>
          <a:off x="1402776" y="1822970"/>
          <a:ext cx="6162032" cy="352835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288967"/>
                <a:gridCol w="4873065"/>
              </a:tblGrid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rimers for RT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5’ → 3’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HIKV + stran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AATACGACTCACTATAGGGACGAAACCACTGTATCACAGC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CHIKV - stran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CGGCAGTATCGTGAATTCGATGCAGACCTGACGGAAGGTAGACG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AYV + stran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TAATACGACTCACTATAGGGCGGTTTCATTCTCTTCTTCCTC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AYV </a:t>
                      </a:r>
                      <a:r>
                        <a:rPr lang="en-US" sz="1100" dirty="0" smtClean="0">
                          <a:effectLst/>
                        </a:rPr>
                        <a:t>– </a:t>
                      </a:r>
                      <a:r>
                        <a:rPr lang="en-US" sz="1100" dirty="0">
                          <a:effectLst/>
                        </a:rPr>
                        <a:t>strand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CGGCAGTATCGTGAATTCGATGCCCAGGCAATGAAAGGAGTACG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Primers for qPCR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HIKV + 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aataaatcataaCGTACTGTTCTCAGTCGGGTC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HIKV + 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aataaatcataaTAATACGACTCACTATAGGG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HIKV - 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aataaatcataaTCGGCAGTATCGTGAATTCGATGC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HIKV -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aataaatcataaGATGGAACACTGAAGGTAAGTGC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AYV + 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aataaatcataa</a:t>
                      </a:r>
                      <a:r>
                        <a:rPr lang="en-US" sz="1100" dirty="0">
                          <a:effectLst/>
                        </a:rPr>
                        <a:t> CCTACCCAACATATGCAACCA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AYV + 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aataaatcataaTAATACGACTCACTATAGGG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AYV - F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aataaatcataaTCGGCAGTATCGTGAATTCGATGC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AYV - R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aataaatcataaAAGGTGTCCCTCAGTCAGT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Probe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CHIKV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TACCCGGAGAGCCGTAAGCTTCTTA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  <a:tr h="20755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MAYV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ACGAACAGGTGTTGAAAGCCAGGA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0" marB="0"/>
                </a:tc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1346139" y="1452478"/>
            <a:ext cx="6101406" cy="25391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US" alt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1.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ligonucleotide 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rimers 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sed for </a:t>
            </a:r>
            <a:r>
              <a:rPr lang="en-US" alt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qman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qRT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-PCR to detect CHIKV and 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AYV </a:t>
            </a:r>
            <a:r>
              <a:rPr lang="en-US" altLang="en-US" sz="12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DNAs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54826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62935083"/>
              </p:ext>
            </p:extLst>
          </p:nvPr>
        </p:nvGraphicFramePr>
        <p:xfrm>
          <a:off x="958837" y="856816"/>
          <a:ext cx="6091668" cy="556661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33963"/>
                <a:gridCol w="1647712"/>
                <a:gridCol w="1648415"/>
                <a:gridCol w="1461578"/>
              </a:tblGrid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 err="1">
                          <a:effectLst/>
                        </a:rPr>
                        <a:t>sugarfed</a:t>
                      </a:r>
                      <a:r>
                        <a:rPr lang="en-US" sz="1100" dirty="0">
                          <a:effectLst/>
                        </a:rPr>
                        <a:t> female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idgut diameter (</a:t>
                      </a:r>
                      <a:r>
                        <a:rPr lang="en-US" sz="1100" dirty="0">
                          <a:effectLst/>
                          <a:latin typeface="Symbol" panose="05050102010706020507" pitchFamily="18" charset="2"/>
                        </a:rPr>
                        <a:t>m</a:t>
                      </a:r>
                      <a:r>
                        <a:rPr lang="en-US" sz="1100" dirty="0">
                          <a:effectLst/>
                        </a:rPr>
                        <a:t>m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idgut length (</a:t>
                      </a:r>
                      <a:r>
                        <a:rPr lang="en-US" sz="1100" dirty="0">
                          <a:effectLst/>
                          <a:latin typeface="Symbol" panose="05050102010706020507" pitchFamily="18" charset="2"/>
                        </a:rPr>
                        <a:t>m</a:t>
                      </a:r>
                      <a:r>
                        <a:rPr lang="en-US" sz="1100" dirty="0">
                          <a:effectLst/>
                        </a:rPr>
                        <a:t>m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midgut volume (</a:t>
                      </a:r>
                      <a:r>
                        <a:rPr lang="en-US" sz="1100" dirty="0">
                          <a:effectLst/>
                          <a:latin typeface="Symbol" panose="05050102010706020507" pitchFamily="18" charset="2"/>
                        </a:rPr>
                        <a:t>m</a:t>
                      </a:r>
                      <a:r>
                        <a:rPr lang="en-US" sz="1100" dirty="0">
                          <a:effectLst/>
                        </a:rPr>
                        <a:t>l)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1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0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4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2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1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6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0.1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7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# 1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0.2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average 0.19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std. deviation 0.05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bloodfed femal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midgut diameter (</a:t>
                      </a: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  <a:latin typeface="Symbol" panose="05050102010706020507" pitchFamily="18" charset="2"/>
                        </a:rPr>
                        <a:t>m</a:t>
                      </a: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m)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midgut length (</a:t>
                      </a: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  <a:latin typeface="Symbol" panose="05050102010706020507" pitchFamily="18" charset="2"/>
                        </a:rPr>
                        <a:t>m</a:t>
                      </a: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m)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midgut volume (</a:t>
                      </a: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  <a:latin typeface="Symbol" panose="05050102010706020507" pitchFamily="18" charset="2"/>
                        </a:rPr>
                        <a:t>m</a:t>
                      </a:r>
                      <a:r>
                        <a:rPr lang="en-US" sz="1100" b="1" dirty="0">
                          <a:solidFill>
                            <a:schemeClr val="bg1"/>
                          </a:solidFill>
                          <a:effectLst/>
                        </a:rPr>
                        <a:t>l)</a:t>
                      </a:r>
                      <a:endParaRPr lang="en-US" sz="11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>
                    <a:solidFill>
                      <a:schemeClr val="accent1"/>
                    </a:solidFill>
                  </a:tcPr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4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3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9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3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5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3.3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4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2.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.0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7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.4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.4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.31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4.46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# 1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1.3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2.8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3.72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average 3.889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  <a:tr h="206171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 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std. deviation 0.457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6209" marR="46209" marT="0" marB="0"/>
                </a:tc>
              </a:tr>
            </a:tbl>
          </a:graphicData>
        </a:graphic>
      </p:graphicFrame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874615" y="278298"/>
            <a:ext cx="6936466" cy="43858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68580" tIns="34290" rIns="68580" bIns="3429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ble </a:t>
            </a:r>
            <a:r>
              <a:rPr lang="en-US" altLang="en-US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2.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zes and volumes of midguts obtained from </a:t>
            </a:r>
            <a:r>
              <a:rPr lang="en-US" alt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garfed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altLang="en-US" sz="1200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oodfed</a:t>
            </a:r>
            <a:r>
              <a:rPr lang="en-US" alt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immediately after </a:t>
            </a:r>
            <a:r>
              <a:rPr lang="en-US" altLang="en-US" sz="1200" dirty="0" err="1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oodfeeding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altLang="en-US" sz="1200" i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edes </a:t>
            </a:r>
            <a:r>
              <a:rPr lang="en-US" altLang="en-US" sz="1200" i="1" dirty="0" err="1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egypti</a:t>
            </a:r>
            <a:r>
              <a:rPr lang="en-US" altLang="en-US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n-US" altLang="en-US" sz="1200" dirty="0"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07443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73</TotalTime>
  <Words>681</Words>
  <Application>Microsoft Office PowerPoint</Application>
  <PresentationFormat>On-screen Show (4:3)</PresentationFormat>
  <Paragraphs>24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mkt33@mail.missouri.edu</dc:creator>
  <cp:lastModifiedBy>Franz, Alexander W.</cp:lastModifiedBy>
  <cp:revision>43</cp:revision>
  <cp:lastPrinted>2018-08-01T18:13:01Z</cp:lastPrinted>
  <dcterms:created xsi:type="dcterms:W3CDTF">2018-04-25T14:08:56Z</dcterms:created>
  <dcterms:modified xsi:type="dcterms:W3CDTF">2018-10-17T21:14:18Z</dcterms:modified>
</cp:coreProperties>
</file>